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18288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 showGuides="1">
      <p:cViewPr>
        <p:scale>
          <a:sx n="50" d="100"/>
          <a:sy n="50" d="100"/>
        </p:scale>
        <p:origin x="1836" y="105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86000" y="1496484"/>
            <a:ext cx="137160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4802717"/>
            <a:ext cx="13716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841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911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0" y="486834"/>
            <a:ext cx="394335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0" y="486834"/>
            <a:ext cx="1160145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047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544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5" y="2279652"/>
            <a:ext cx="157734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5" y="6119285"/>
            <a:ext cx="157734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448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2434167"/>
            <a:ext cx="77724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2434167"/>
            <a:ext cx="77724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045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486834"/>
            <a:ext cx="157734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3" y="2241551"/>
            <a:ext cx="7736681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3" y="3340100"/>
            <a:ext cx="7736681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0" y="2241551"/>
            <a:ext cx="7774782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0" y="3340100"/>
            <a:ext cx="7774782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891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415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3" y="609600"/>
            <a:ext cx="5898356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316567"/>
            <a:ext cx="92583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3" y="2743200"/>
            <a:ext cx="5898356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933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3" y="609600"/>
            <a:ext cx="5898356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316567"/>
            <a:ext cx="92583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3" y="2743200"/>
            <a:ext cx="5898356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911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486834"/>
            <a:ext cx="157734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2434167"/>
            <a:ext cx="157734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8475134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A54FB2-ADBC-452F-934B-55670F4C1AF8}" type="datetimeFigureOut">
              <a:rPr lang="en-US" smtClean="0"/>
              <a:t>1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8475134"/>
            <a:ext cx="6172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8475134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C934E-6F88-4E8E-9B09-182BA2EEF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770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B607A6A-820F-4F93-9A29-E3FAFA23FD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493492"/>
              </p:ext>
            </p:extLst>
          </p:nvPr>
        </p:nvGraphicFramePr>
        <p:xfrm>
          <a:off x="496853" y="746125"/>
          <a:ext cx="13971623" cy="67691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144697">
                  <a:extLst>
                    <a:ext uri="{9D8B030D-6E8A-4147-A177-3AD203B41FA5}">
                      <a16:colId xmlns:a16="http://schemas.microsoft.com/office/drawing/2014/main" val="3796553283"/>
                    </a:ext>
                  </a:extLst>
                </a:gridCol>
                <a:gridCol w="1348208">
                  <a:extLst>
                    <a:ext uri="{9D8B030D-6E8A-4147-A177-3AD203B41FA5}">
                      <a16:colId xmlns:a16="http://schemas.microsoft.com/office/drawing/2014/main" val="3984424287"/>
                    </a:ext>
                  </a:extLst>
                </a:gridCol>
                <a:gridCol w="1746453">
                  <a:extLst>
                    <a:ext uri="{9D8B030D-6E8A-4147-A177-3AD203B41FA5}">
                      <a16:colId xmlns:a16="http://schemas.microsoft.com/office/drawing/2014/main" val="4225127046"/>
                    </a:ext>
                  </a:extLst>
                </a:gridCol>
                <a:gridCol w="1746453">
                  <a:extLst>
                    <a:ext uri="{9D8B030D-6E8A-4147-A177-3AD203B41FA5}">
                      <a16:colId xmlns:a16="http://schemas.microsoft.com/office/drawing/2014/main" val="2532987631"/>
                    </a:ext>
                  </a:extLst>
                </a:gridCol>
                <a:gridCol w="1746453">
                  <a:extLst>
                    <a:ext uri="{9D8B030D-6E8A-4147-A177-3AD203B41FA5}">
                      <a16:colId xmlns:a16="http://schemas.microsoft.com/office/drawing/2014/main" val="130376159"/>
                    </a:ext>
                  </a:extLst>
                </a:gridCol>
                <a:gridCol w="1746453">
                  <a:extLst>
                    <a:ext uri="{9D8B030D-6E8A-4147-A177-3AD203B41FA5}">
                      <a16:colId xmlns:a16="http://schemas.microsoft.com/office/drawing/2014/main" val="1699332504"/>
                    </a:ext>
                  </a:extLst>
                </a:gridCol>
                <a:gridCol w="1746453">
                  <a:extLst>
                    <a:ext uri="{9D8B030D-6E8A-4147-A177-3AD203B41FA5}">
                      <a16:colId xmlns:a16="http://schemas.microsoft.com/office/drawing/2014/main" val="846577215"/>
                    </a:ext>
                  </a:extLst>
                </a:gridCol>
                <a:gridCol w="1746453">
                  <a:extLst>
                    <a:ext uri="{9D8B030D-6E8A-4147-A177-3AD203B41FA5}">
                      <a16:colId xmlns:a16="http://schemas.microsoft.com/office/drawing/2014/main" val="1185279354"/>
                    </a:ext>
                  </a:extLst>
                </a:gridCol>
              </a:tblGrid>
              <a:tr h="720725">
                <a:tc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P 14-21D Infusio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P 0-21D Infusio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6416672"/>
                  </a:ext>
                </a:extLst>
              </a:tr>
              <a:tr h="762000">
                <a:tc>
                  <a:txBody>
                    <a:bodyPr/>
                    <a:lstStyle/>
                    <a:p>
                      <a:pPr algn="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t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923528"/>
                  </a:ext>
                </a:extLst>
              </a:tr>
              <a:tr h="485775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dy weight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3.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8.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4.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4407632"/>
                  </a:ext>
                </a:extLst>
              </a:tr>
              <a:tr h="565404">
                <a:tc gridSpan="8">
                  <a:txBody>
                    <a:bodyPr/>
                    <a:lstStyle/>
                    <a:p>
                      <a:pPr algn="ctr"/>
                      <a:r>
                        <a:rPr lang="en-US" sz="2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T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7336011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 Flow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/day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88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11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5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8145526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ol/da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2*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*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5087888"/>
                  </a:ext>
                </a:extLst>
              </a:tr>
              <a:tr h="441833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orid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ol/da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8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3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89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</a:t>
                      </a:r>
                      <a:endParaRPr lang="en-US" sz="1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2771634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tassi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ol/da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**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**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3402095"/>
                  </a:ext>
                </a:extLst>
              </a:tr>
              <a:tr h="597154">
                <a:tc gridSpan="8">
                  <a:txBody>
                    <a:bodyPr/>
                    <a:lstStyle/>
                    <a:p>
                      <a:pPr algn="ctr"/>
                      <a:r>
                        <a:rPr lang="en-US" sz="2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>
                      <a:noFill/>
                    </a:lnL>
                    <a:lnT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6746216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.75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.88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.11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299526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orid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.38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.38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.33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7752833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tassi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6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1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7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7540140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i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8373665"/>
                  </a:ext>
                </a:extLst>
              </a:tr>
              <a:tr h="507873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atinin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d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*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*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191104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70C4741-5E47-42B2-8D71-9161D6A08A76}"/>
              </a:ext>
            </a:extLst>
          </p:cNvPr>
          <p:cNvSpPr txBox="1"/>
          <p:nvPr/>
        </p:nvSpPr>
        <p:spPr>
          <a:xfrm>
            <a:off x="352425" y="140474"/>
            <a:ext cx="1684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rine and plasma parameters of the male SS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rats infused with ANP or vehicle at the end of the 21-day HS challenge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9FECC43-71A9-4537-A5E2-03FD7D6826CA}"/>
              </a:ext>
            </a:extLst>
          </p:cNvPr>
          <p:cNvSpPr txBox="1"/>
          <p:nvPr/>
        </p:nvSpPr>
        <p:spPr>
          <a:xfrm>
            <a:off x="496853" y="7602381"/>
            <a:ext cx="843741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 p-value &lt;0.001, vehicle vs 0-21D infusion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* p-value &lt;0.001, vehicle vs 14-21D infusion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‡ p-value &lt;0.001, 14-21D infusion vs 0-21D infusion</a:t>
            </a:r>
          </a:p>
        </p:txBody>
      </p:sp>
    </p:spTree>
    <p:extLst>
      <p:ext uri="{BB962C8B-B14F-4D97-AF65-F5344CB8AC3E}">
        <p14:creationId xmlns:p14="http://schemas.microsoft.com/office/powerpoint/2010/main" val="29197380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9E2E628-A42A-4CE2-BA34-C4E865D58A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6997246"/>
              </p:ext>
            </p:extLst>
          </p:nvPr>
        </p:nvGraphicFramePr>
        <p:xfrm>
          <a:off x="457200" y="552450"/>
          <a:ext cx="16747212" cy="7264527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895764">
                  <a:extLst>
                    <a:ext uri="{9D8B030D-6E8A-4147-A177-3AD203B41FA5}">
                      <a16:colId xmlns:a16="http://schemas.microsoft.com/office/drawing/2014/main" val="3796553283"/>
                    </a:ext>
                  </a:extLst>
                </a:gridCol>
                <a:gridCol w="1885256">
                  <a:extLst>
                    <a:ext uri="{9D8B030D-6E8A-4147-A177-3AD203B41FA5}">
                      <a16:colId xmlns:a16="http://schemas.microsoft.com/office/drawing/2014/main" val="347161687"/>
                    </a:ext>
                  </a:extLst>
                </a:gridCol>
                <a:gridCol w="2331720">
                  <a:extLst>
                    <a:ext uri="{9D8B030D-6E8A-4147-A177-3AD203B41FA5}">
                      <a16:colId xmlns:a16="http://schemas.microsoft.com/office/drawing/2014/main" val="4225127046"/>
                    </a:ext>
                  </a:extLst>
                </a:gridCol>
                <a:gridCol w="1453896">
                  <a:extLst>
                    <a:ext uri="{9D8B030D-6E8A-4147-A177-3AD203B41FA5}">
                      <a16:colId xmlns:a16="http://schemas.microsoft.com/office/drawing/2014/main" val="2788407919"/>
                    </a:ext>
                  </a:extLst>
                </a:gridCol>
                <a:gridCol w="1911096">
                  <a:extLst>
                    <a:ext uri="{9D8B030D-6E8A-4147-A177-3AD203B41FA5}">
                      <a16:colId xmlns:a16="http://schemas.microsoft.com/office/drawing/2014/main" val="2897246032"/>
                    </a:ext>
                  </a:extLst>
                </a:gridCol>
                <a:gridCol w="1453896">
                  <a:extLst>
                    <a:ext uri="{9D8B030D-6E8A-4147-A177-3AD203B41FA5}">
                      <a16:colId xmlns:a16="http://schemas.microsoft.com/office/drawing/2014/main" val="2532987631"/>
                    </a:ext>
                  </a:extLst>
                </a:gridCol>
                <a:gridCol w="1453896">
                  <a:extLst>
                    <a:ext uri="{9D8B030D-6E8A-4147-A177-3AD203B41FA5}">
                      <a16:colId xmlns:a16="http://schemas.microsoft.com/office/drawing/2014/main" val="130376159"/>
                    </a:ext>
                  </a:extLst>
                </a:gridCol>
                <a:gridCol w="1453896">
                  <a:extLst>
                    <a:ext uri="{9D8B030D-6E8A-4147-A177-3AD203B41FA5}">
                      <a16:colId xmlns:a16="http://schemas.microsoft.com/office/drawing/2014/main" val="1699332504"/>
                    </a:ext>
                  </a:extLst>
                </a:gridCol>
                <a:gridCol w="1453896">
                  <a:extLst>
                    <a:ext uri="{9D8B030D-6E8A-4147-A177-3AD203B41FA5}">
                      <a16:colId xmlns:a16="http://schemas.microsoft.com/office/drawing/2014/main" val="846577215"/>
                    </a:ext>
                  </a:extLst>
                </a:gridCol>
                <a:gridCol w="1453896">
                  <a:extLst>
                    <a:ext uri="{9D8B030D-6E8A-4147-A177-3AD203B41FA5}">
                      <a16:colId xmlns:a16="http://schemas.microsoft.com/office/drawing/2014/main" val="1185279354"/>
                    </a:ext>
                  </a:extLst>
                </a:gridCol>
              </a:tblGrid>
              <a:tr h="574548">
                <a:tc>
                  <a:txBody>
                    <a:bodyPr/>
                    <a:lstStyle/>
                    <a:p>
                      <a:pPr algn="ctr"/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</a:t>
                      </a:r>
                      <a:r>
                        <a:rPr lang="en-US" sz="2400" b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2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</a:t>
                      </a:r>
                      <a:r>
                        <a:rPr lang="en-US" sz="2400" b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PA-/-</a:t>
                      </a:r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6416672"/>
                  </a:ext>
                </a:extLst>
              </a:tr>
              <a:tr h="654177">
                <a:tc>
                  <a:txBody>
                    <a:bodyPr/>
                    <a:lstStyle/>
                    <a:p>
                      <a:pPr algn="ctr"/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2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2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2946432"/>
                  </a:ext>
                </a:extLst>
              </a:tr>
              <a:tr h="542925">
                <a:tc>
                  <a:txBody>
                    <a:bodyPr/>
                    <a:lstStyle/>
                    <a:p>
                      <a:pPr algn="ctr"/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t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923528"/>
                  </a:ext>
                </a:extLst>
              </a:tr>
              <a:tr h="523875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dy weight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7.6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8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7.8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0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5.11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2.57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2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8145526"/>
                  </a:ext>
                </a:extLst>
              </a:tr>
              <a:tr h="568833">
                <a:tc gridSpan="10">
                  <a:txBody>
                    <a:bodyPr/>
                    <a:lstStyle/>
                    <a:p>
                      <a:pPr algn="ctr"/>
                      <a:r>
                        <a:rPr lang="en-US" sz="2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  <a:endParaRPr lang="en-US" sz="1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4000576"/>
                  </a:ext>
                </a:extLst>
              </a:tr>
              <a:tr h="447675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tassi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ol/24h/100g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3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1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5087888"/>
                  </a:ext>
                </a:extLst>
              </a:tr>
              <a:tr h="473202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i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ol/24h/100g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7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9E-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2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</a:t>
                      </a:r>
                      <a:endParaRPr lang="en-US" sz="18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4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33E-04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5E-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72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2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2771634"/>
                  </a:ext>
                </a:extLst>
              </a:tr>
              <a:tr h="501396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atinin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ol/24h/100g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6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5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5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0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3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3402095"/>
                  </a:ext>
                </a:extLst>
              </a:tr>
              <a:tr h="580644">
                <a:tc gridSpan="10">
                  <a:txBody>
                    <a:bodyPr/>
                    <a:lstStyle/>
                    <a:p>
                      <a:pPr algn="ctr"/>
                      <a:r>
                        <a:rPr lang="en-US" sz="2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6746216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r>
                        <a:rPr lang="en-US" sz="19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otein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</a:t>
                      </a:r>
                      <a:r>
                        <a:rPr lang="en-US" sz="1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49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5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1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50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299526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obuli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</a:t>
                      </a:r>
                      <a:r>
                        <a:rPr lang="en-US" sz="1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4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3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9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7752833"/>
                  </a:ext>
                </a:extLst>
              </a:tr>
              <a:tr h="477012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bum/Glob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.u</a:t>
                      </a: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6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7540140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(GPT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/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.14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‡‡5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6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.67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8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.38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8373665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k</a:t>
                      </a: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ase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/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8.14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.1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6.29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6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4.83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.3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3.13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.5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1911041"/>
                  </a:ext>
                </a:extLst>
              </a:tr>
              <a:tr h="384048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lestero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</a:t>
                      </a:r>
                      <a:r>
                        <a:rPr lang="en-US" sz="1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9.71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3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5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9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9.67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6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3.7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984372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923B54D-E184-4DB8-9BC6-C3C2F59D966A}"/>
              </a:ext>
            </a:extLst>
          </p:cNvPr>
          <p:cNvSpPr txBox="1"/>
          <p:nvPr/>
        </p:nvSpPr>
        <p:spPr>
          <a:xfrm>
            <a:off x="350870" y="46810"/>
            <a:ext cx="13452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rine and plasma parameters of the male SS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nd SS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NPPA-/-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 rats; normal salt (NS) vs high salt (HS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1BBF9E3-6037-466F-9D15-27758B74E1FC}"/>
              </a:ext>
            </a:extLst>
          </p:cNvPr>
          <p:cNvSpPr txBox="1"/>
          <p:nvPr/>
        </p:nvSpPr>
        <p:spPr>
          <a:xfrm>
            <a:off x="457200" y="7880715"/>
            <a:ext cx="843741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* p-value &lt;0.05,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vs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 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** p-value &lt;0.05,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vs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 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‡ p-value &lt;0.05,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s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 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‡ ‡ p-value &lt;0.05,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s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95655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531F621-1E93-4A2C-83D7-DC00B7C33E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3141434"/>
              </p:ext>
            </p:extLst>
          </p:nvPr>
        </p:nvGraphicFramePr>
        <p:xfrm>
          <a:off x="457751" y="739438"/>
          <a:ext cx="17201047" cy="7090964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566155">
                  <a:extLst>
                    <a:ext uri="{9D8B030D-6E8A-4147-A177-3AD203B41FA5}">
                      <a16:colId xmlns:a16="http://schemas.microsoft.com/office/drawing/2014/main" val="3796553283"/>
                    </a:ext>
                  </a:extLst>
                </a:gridCol>
                <a:gridCol w="1176835">
                  <a:extLst>
                    <a:ext uri="{9D8B030D-6E8A-4147-A177-3AD203B41FA5}">
                      <a16:colId xmlns:a16="http://schemas.microsoft.com/office/drawing/2014/main" val="347161687"/>
                    </a:ext>
                  </a:extLst>
                </a:gridCol>
                <a:gridCol w="2049655">
                  <a:extLst>
                    <a:ext uri="{9D8B030D-6E8A-4147-A177-3AD203B41FA5}">
                      <a16:colId xmlns:a16="http://schemas.microsoft.com/office/drawing/2014/main" val="4225127046"/>
                    </a:ext>
                  </a:extLst>
                </a:gridCol>
                <a:gridCol w="1559307">
                  <a:extLst>
                    <a:ext uri="{9D8B030D-6E8A-4147-A177-3AD203B41FA5}">
                      <a16:colId xmlns:a16="http://schemas.microsoft.com/office/drawing/2014/main" val="2788407919"/>
                    </a:ext>
                  </a:extLst>
                </a:gridCol>
                <a:gridCol w="1559307">
                  <a:extLst>
                    <a:ext uri="{9D8B030D-6E8A-4147-A177-3AD203B41FA5}">
                      <a16:colId xmlns:a16="http://schemas.microsoft.com/office/drawing/2014/main" val="2897246032"/>
                    </a:ext>
                  </a:extLst>
                </a:gridCol>
                <a:gridCol w="1559307">
                  <a:extLst>
                    <a:ext uri="{9D8B030D-6E8A-4147-A177-3AD203B41FA5}">
                      <a16:colId xmlns:a16="http://schemas.microsoft.com/office/drawing/2014/main" val="2532987631"/>
                    </a:ext>
                  </a:extLst>
                </a:gridCol>
                <a:gridCol w="2052560">
                  <a:extLst>
                    <a:ext uri="{9D8B030D-6E8A-4147-A177-3AD203B41FA5}">
                      <a16:colId xmlns:a16="http://schemas.microsoft.com/office/drawing/2014/main" val="130376159"/>
                    </a:ext>
                  </a:extLst>
                </a:gridCol>
                <a:gridCol w="1559307">
                  <a:extLst>
                    <a:ext uri="{9D8B030D-6E8A-4147-A177-3AD203B41FA5}">
                      <a16:colId xmlns:a16="http://schemas.microsoft.com/office/drawing/2014/main" val="1699332504"/>
                    </a:ext>
                  </a:extLst>
                </a:gridCol>
                <a:gridCol w="1559307">
                  <a:extLst>
                    <a:ext uri="{9D8B030D-6E8A-4147-A177-3AD203B41FA5}">
                      <a16:colId xmlns:a16="http://schemas.microsoft.com/office/drawing/2014/main" val="846577215"/>
                    </a:ext>
                  </a:extLst>
                </a:gridCol>
                <a:gridCol w="1559307">
                  <a:extLst>
                    <a:ext uri="{9D8B030D-6E8A-4147-A177-3AD203B41FA5}">
                      <a16:colId xmlns:a16="http://schemas.microsoft.com/office/drawing/2014/main" val="1185279354"/>
                    </a:ext>
                  </a:extLst>
                </a:gridCol>
              </a:tblGrid>
              <a:tr h="651212">
                <a:tc>
                  <a:txBody>
                    <a:bodyPr/>
                    <a:lstStyle/>
                    <a:p>
                      <a:pPr algn="ctr"/>
                      <a:endParaRPr lang="en-US" sz="2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</a:t>
                      </a:r>
                      <a:r>
                        <a:rPr lang="en-US" sz="2400" b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2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</a:t>
                      </a:r>
                      <a:r>
                        <a:rPr lang="en-US" sz="2400" b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PA-/-</a:t>
                      </a:r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6416672"/>
                  </a:ext>
                </a:extLst>
              </a:tr>
              <a:tr h="557629">
                <a:tc>
                  <a:txBody>
                    <a:bodyPr/>
                    <a:lstStyle/>
                    <a:p>
                      <a:pPr algn="ctr"/>
                      <a:endParaRPr lang="en-US" sz="2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2946432"/>
                  </a:ext>
                </a:extLst>
              </a:tr>
              <a:tr h="512683">
                <a:tc>
                  <a:txBody>
                    <a:bodyPr/>
                    <a:lstStyle/>
                    <a:p>
                      <a:pPr algn="ctr"/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t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923528"/>
                  </a:ext>
                </a:extLst>
              </a:tr>
              <a:tr h="395704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ol/L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6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9.5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0.27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9.27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8145526"/>
                  </a:ext>
                </a:extLst>
              </a:tr>
              <a:tr h="395704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orid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mol/L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.6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3.2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.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7.1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5087888"/>
                  </a:ext>
                </a:extLst>
              </a:tr>
              <a:tr h="395704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tassiu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mol/L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6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9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9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2771634"/>
                  </a:ext>
                </a:extLst>
              </a:tr>
              <a:tr h="395704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atinin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9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3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2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2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3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2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3402095"/>
                  </a:ext>
                </a:extLst>
              </a:tr>
              <a:tr h="395704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</a:t>
                      </a:r>
                      <a:r>
                        <a:rPr lang="en-US" sz="1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.5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07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.42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.1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17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299526"/>
                  </a:ext>
                </a:extLst>
              </a:tr>
              <a:tr h="687786">
                <a:tc gridSpan="10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AS Metabolite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7752833"/>
                  </a:ext>
                </a:extLst>
              </a:tr>
              <a:tr h="395704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</a:t>
                      </a: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 (1-0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47.92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5.0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3.19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.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61.8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.7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1.28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1.5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7540140"/>
                  </a:ext>
                </a:extLst>
              </a:tr>
              <a:tr h="606961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tensin III (2-8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M</a:t>
                      </a:r>
                      <a:endParaRPr kumimoji="0" 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.73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12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.50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7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08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8373665"/>
                  </a:ext>
                </a:extLst>
              </a:tr>
              <a:tr h="395704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tensin 1-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M</a:t>
                      </a:r>
                      <a:endParaRPr kumimoji="0" 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35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7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.45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9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.43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3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1911041"/>
                  </a:ext>
                </a:extLst>
              </a:tr>
              <a:tr h="395704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tensin 1-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M</a:t>
                      </a:r>
                      <a:endParaRPr kumimoji="0" 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5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07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9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.3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4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57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8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9843726"/>
                  </a:ext>
                </a:extLst>
              </a:tr>
              <a:tr h="528061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tensin IV (3-8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8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M</a:t>
                      </a:r>
                      <a:endParaRPr kumimoji="0" lang="en-US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.3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4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73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9.12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5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22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29184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E activit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.u</a:t>
                      </a: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2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4</a:t>
                      </a: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6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7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3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194391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7EB3634-E556-49BA-8C72-750BE613885C}"/>
              </a:ext>
            </a:extLst>
          </p:cNvPr>
          <p:cNvSpPr txBox="1"/>
          <p:nvPr/>
        </p:nvSpPr>
        <p:spPr>
          <a:xfrm>
            <a:off x="363051" y="230335"/>
            <a:ext cx="13447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: Plasma parameters of the male SS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nd SS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NPPA-/-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 rats; normal salt (NS) vs high salt (HS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5430E8E-585E-48D0-9AF6-ADA2FB63A289}"/>
              </a:ext>
            </a:extLst>
          </p:cNvPr>
          <p:cNvSpPr txBox="1"/>
          <p:nvPr/>
        </p:nvSpPr>
        <p:spPr>
          <a:xfrm>
            <a:off x="457200" y="7830402"/>
            <a:ext cx="843741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* p-value &lt;0.05,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vs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 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** p-value &lt;0.05,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vs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‡ p-value &lt;0.05,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s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endParaRPr lang="en-US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‡ ‡ p-value &lt;0.05,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s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endParaRPr lang="en-US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86259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B4494FF-46E5-4822-B9E4-5B7187A467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5626019"/>
              </p:ext>
            </p:extLst>
          </p:nvPr>
        </p:nvGraphicFramePr>
        <p:xfrm>
          <a:off x="447675" y="622299"/>
          <a:ext cx="17706978" cy="4025901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3737649">
                  <a:extLst>
                    <a:ext uri="{9D8B030D-6E8A-4147-A177-3AD203B41FA5}">
                      <a16:colId xmlns:a16="http://schemas.microsoft.com/office/drawing/2014/main" val="3796553283"/>
                    </a:ext>
                  </a:extLst>
                </a:gridCol>
                <a:gridCol w="1237902">
                  <a:extLst>
                    <a:ext uri="{9D8B030D-6E8A-4147-A177-3AD203B41FA5}">
                      <a16:colId xmlns:a16="http://schemas.microsoft.com/office/drawing/2014/main" val="347161687"/>
                    </a:ext>
                  </a:extLst>
                </a:gridCol>
                <a:gridCol w="2289502">
                  <a:extLst>
                    <a:ext uri="{9D8B030D-6E8A-4147-A177-3AD203B41FA5}">
                      <a16:colId xmlns:a16="http://schemas.microsoft.com/office/drawing/2014/main" val="4225127046"/>
                    </a:ext>
                  </a:extLst>
                </a:gridCol>
                <a:gridCol w="1427572">
                  <a:extLst>
                    <a:ext uri="{9D8B030D-6E8A-4147-A177-3AD203B41FA5}">
                      <a16:colId xmlns:a16="http://schemas.microsoft.com/office/drawing/2014/main" val="2788407919"/>
                    </a:ext>
                  </a:extLst>
                </a:gridCol>
                <a:gridCol w="1427572">
                  <a:extLst>
                    <a:ext uri="{9D8B030D-6E8A-4147-A177-3AD203B41FA5}">
                      <a16:colId xmlns:a16="http://schemas.microsoft.com/office/drawing/2014/main" val="2897246032"/>
                    </a:ext>
                  </a:extLst>
                </a:gridCol>
                <a:gridCol w="1427572">
                  <a:extLst>
                    <a:ext uri="{9D8B030D-6E8A-4147-A177-3AD203B41FA5}">
                      <a16:colId xmlns:a16="http://schemas.microsoft.com/office/drawing/2014/main" val="2532987631"/>
                    </a:ext>
                  </a:extLst>
                </a:gridCol>
                <a:gridCol w="1876493">
                  <a:extLst>
                    <a:ext uri="{9D8B030D-6E8A-4147-A177-3AD203B41FA5}">
                      <a16:colId xmlns:a16="http://schemas.microsoft.com/office/drawing/2014/main" val="130376159"/>
                    </a:ext>
                  </a:extLst>
                </a:gridCol>
                <a:gridCol w="1427572">
                  <a:extLst>
                    <a:ext uri="{9D8B030D-6E8A-4147-A177-3AD203B41FA5}">
                      <a16:colId xmlns:a16="http://schemas.microsoft.com/office/drawing/2014/main" val="1699332504"/>
                    </a:ext>
                  </a:extLst>
                </a:gridCol>
                <a:gridCol w="1427572">
                  <a:extLst>
                    <a:ext uri="{9D8B030D-6E8A-4147-A177-3AD203B41FA5}">
                      <a16:colId xmlns:a16="http://schemas.microsoft.com/office/drawing/2014/main" val="846577215"/>
                    </a:ext>
                  </a:extLst>
                </a:gridCol>
                <a:gridCol w="1427572">
                  <a:extLst>
                    <a:ext uri="{9D8B030D-6E8A-4147-A177-3AD203B41FA5}">
                      <a16:colId xmlns:a16="http://schemas.microsoft.com/office/drawing/2014/main" val="1185279354"/>
                    </a:ext>
                  </a:extLst>
                </a:gridCol>
              </a:tblGrid>
              <a:tr h="668435">
                <a:tc>
                  <a:txBody>
                    <a:bodyPr/>
                    <a:lstStyle/>
                    <a:p>
                      <a:pPr algn="ctr"/>
                      <a:endParaRPr lang="en-US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</a:t>
                      </a:r>
                      <a:r>
                        <a:rPr lang="en-US" sz="2400" b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2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</a:t>
                      </a:r>
                      <a:r>
                        <a:rPr lang="en-US" sz="2400" b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PA-/-</a:t>
                      </a:r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06416672"/>
                  </a:ext>
                </a:extLst>
              </a:tr>
              <a:tr h="571511">
                <a:tc>
                  <a:txBody>
                    <a:bodyPr/>
                    <a:lstStyle/>
                    <a:p>
                      <a:pPr algn="ctr"/>
                      <a:endParaRPr lang="en-US" sz="2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2946432"/>
                  </a:ext>
                </a:extLst>
              </a:tr>
              <a:tr h="671776">
                <a:tc>
                  <a:txBody>
                    <a:bodyPr/>
                    <a:lstStyle/>
                    <a:p>
                      <a:pPr algn="r"/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t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</a:p>
                  </a:txBody>
                  <a:tcPr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923528"/>
                  </a:ext>
                </a:extLst>
              </a:tr>
              <a:tr h="42350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 systolic</a:t>
                      </a:r>
                      <a:r>
                        <a:rPr lang="en-US" sz="19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entral wall thickness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5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6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73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48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30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8145526"/>
                  </a:ext>
                </a:extLst>
              </a:tr>
              <a:tr h="42350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 systolic</a:t>
                      </a:r>
                      <a:r>
                        <a:rPr lang="en-US" sz="19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hamber diameter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4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54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6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7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5087888"/>
                  </a:ext>
                </a:extLst>
              </a:tr>
              <a:tr h="42350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 systolic</a:t>
                      </a:r>
                      <a:r>
                        <a:rPr lang="en-US" sz="19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orsal wall thickness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93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48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 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44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24</a:t>
                      </a:r>
                      <a:r>
                        <a:rPr lang="en-US" sz="1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; 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2771634"/>
                  </a:ext>
                </a:extLst>
              </a:tr>
              <a:tr h="423508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V systolic</a:t>
                      </a:r>
                      <a:r>
                        <a:rPr lang="en-US" sz="19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hamber diameter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1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0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6</a:t>
                      </a:r>
                      <a:r>
                        <a:rPr lang="en-US" sz="1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‡‡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2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3402095"/>
                  </a:ext>
                </a:extLst>
              </a:tr>
              <a:tr h="420147">
                <a:tc>
                  <a:txBody>
                    <a:bodyPr/>
                    <a:lstStyle/>
                    <a:p>
                      <a:pPr algn="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actional</a:t>
                      </a:r>
                      <a:r>
                        <a:rPr lang="en-US" sz="19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hortening </a:t>
                      </a:r>
                      <a:endParaRPr lang="en-US" sz="19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.41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.1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9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1.28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2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.3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5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29952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91E7119-C893-4020-94A1-BA268CD313E4}"/>
              </a:ext>
            </a:extLst>
          </p:cNvPr>
          <p:cNvSpPr txBox="1"/>
          <p:nvPr/>
        </p:nvSpPr>
        <p:spPr>
          <a:xfrm>
            <a:off x="371475" y="174661"/>
            <a:ext cx="15195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chocardiography parameters of the male SS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nd SS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NPPA-/-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 rats; normal salt (NS) vs high salt (HS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7D188CC-88E7-4942-863A-C38C5600A4FC}"/>
              </a:ext>
            </a:extLst>
          </p:cNvPr>
          <p:cNvSpPr txBox="1"/>
          <p:nvPr/>
        </p:nvSpPr>
        <p:spPr>
          <a:xfrm>
            <a:off x="447675" y="4780195"/>
            <a:ext cx="843741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* p-value &lt;0.05,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vs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 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** p-value &lt;0.05,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vs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 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‡ p-value &lt; 0.05,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s H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; 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‡ ‡ p-value &lt; 0.05,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s NS-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S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PP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98716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</TotalTime>
  <Words>832</Words>
  <Application>Microsoft Office PowerPoint</Application>
  <PresentationFormat>Custom</PresentationFormat>
  <Paragraphs>41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latovskaya, Daria</dc:creator>
  <cp:lastModifiedBy>Ilatovskaya, Daria</cp:lastModifiedBy>
  <cp:revision>25</cp:revision>
  <dcterms:created xsi:type="dcterms:W3CDTF">2022-01-03T19:15:09Z</dcterms:created>
  <dcterms:modified xsi:type="dcterms:W3CDTF">2022-01-27T23:42:52Z</dcterms:modified>
</cp:coreProperties>
</file>